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7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94"/>
  </p:normalViewPr>
  <p:slideViewPr>
    <p:cSldViewPr snapToGrid="0" snapToObjects="1">
      <p:cViewPr varScale="1">
        <p:scale>
          <a:sx n="99" d="100"/>
          <a:sy n="99" d="100"/>
        </p:scale>
        <p:origin x="176" y="6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CE0C7B-3E0E-3749-86BA-94D79B4711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5CD60BF-0523-AA48-9EF0-AD0210DC48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71C07D-798F-2145-B8E1-5C4BE19A3E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488E0-DCBF-FB4E-90E8-11620C376D18}" type="datetimeFigureOut">
              <a:rPr lang="en-US" smtClean="0"/>
              <a:t>3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C525C9-D679-5E4B-80C7-D632E62D8D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0C4585-44B2-AE43-93D4-5276D53B96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63335-745E-6448-8ECA-B389D5C33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2946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3B8C10-3C4E-D148-8082-3D8BDEDEE4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ACA797-F785-F74B-901A-E28059930E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D3E4B7-B239-0C44-8F3C-C5BB65E9E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488E0-DCBF-FB4E-90E8-11620C376D18}" type="datetimeFigureOut">
              <a:rPr lang="en-US" smtClean="0"/>
              <a:t>3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AAF8C5-6273-7442-98EC-F7BEC4429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55C8CD-F194-8C45-854C-F0CFCDCE9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63335-745E-6448-8ECA-B389D5C33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394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1FF27C0-4400-5044-9376-81415775EE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883734-4687-2046-BB51-7E53F75608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6CE1B4-CA83-844E-924A-242CFD210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488E0-DCBF-FB4E-90E8-11620C376D18}" type="datetimeFigureOut">
              <a:rPr lang="en-US" smtClean="0"/>
              <a:t>3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8CDDA8-A1A0-F34C-836B-C8D786A80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AAA1B4-C9D5-B24F-9AE5-6DD3F36865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63335-745E-6448-8ECA-B389D5C33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05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6CDBE0-C5E2-8147-A060-E72ACF5A36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5A4E97-B064-744F-B84C-FE54E89A54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922125-D704-3846-A9A1-644FF9764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488E0-DCBF-FB4E-90E8-11620C376D18}" type="datetimeFigureOut">
              <a:rPr lang="en-US" smtClean="0"/>
              <a:t>3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2E9F79-4893-3443-A0B7-20E656D47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BDD517-8046-884A-A439-876EF4A7D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63335-745E-6448-8ECA-B389D5C33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07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B544FB-2312-6342-B927-D40F602010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69791E-9531-2B48-A34E-47C1B8EA31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75D818-2C61-D14A-8FCC-41DB6FC80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488E0-DCBF-FB4E-90E8-11620C376D18}" type="datetimeFigureOut">
              <a:rPr lang="en-US" smtClean="0"/>
              <a:t>3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07FA07-DF3C-2647-A9C1-1E957BB12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816D09-C047-8542-9C5E-4394C9204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63335-745E-6448-8ECA-B389D5C33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43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F9953E-8004-AF43-BE56-1B3E372268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C7C9F9-C29A-2941-A6BA-048E39C7E5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C0E054-AC72-164F-8CC2-9F8B53B1A8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F50260-4622-3941-95C9-4F88C8C973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488E0-DCBF-FB4E-90E8-11620C376D18}" type="datetimeFigureOut">
              <a:rPr lang="en-US" smtClean="0"/>
              <a:t>3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8D3854-277D-E44D-B489-884B34522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AAF798-82C7-7A48-846B-E43C7C423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63335-745E-6448-8ECA-B389D5C33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991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F6EFCD-31A3-BC4F-8C8E-AD65A068DD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80DE25-2954-3A48-B617-E572B5212F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E3FD72-182F-AD41-9973-84C701A650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814423A-A4E8-C646-B6B2-E28D337589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494BA9-7F8E-DB44-AD93-83A43A1A13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066F0F2-6BD7-7342-B585-37F168CEB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488E0-DCBF-FB4E-90E8-11620C376D18}" type="datetimeFigureOut">
              <a:rPr lang="en-US" smtClean="0"/>
              <a:t>3/1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2E4996A-1F05-D94C-B63C-3AF66F891C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4651BAC-9AC7-2D43-AECA-57A9AB0DE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63335-745E-6448-8ECA-B389D5C33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299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9A186C-F025-6C46-B3DB-802C5D4E4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840838F-20EA-2442-A8DF-78EB0942C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488E0-DCBF-FB4E-90E8-11620C376D18}" type="datetimeFigureOut">
              <a:rPr lang="en-US" smtClean="0"/>
              <a:t>3/1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D4CC19-1BE7-354E-9864-0397483F4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245C45-7BBC-684D-A103-E7FF194A5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63335-745E-6448-8ECA-B389D5C33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513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C01A463-41A7-E544-840D-649D68E64B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488E0-DCBF-FB4E-90E8-11620C376D18}" type="datetimeFigureOut">
              <a:rPr lang="en-US" smtClean="0"/>
              <a:t>3/1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868AB4-8972-8543-A84F-2BB0EA147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7231FC0-DAC6-414C-BA59-0627220B2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63335-745E-6448-8ECA-B389D5C33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62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9AD21F-AAF8-E24A-9FE3-039B9683D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54456F-503B-0840-8D72-ED5072F3D9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7206FF-0CE4-7740-90A8-8DC10818E8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3EEEBB-5ECA-FB48-A548-5FFADBEBBE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488E0-DCBF-FB4E-90E8-11620C376D18}" type="datetimeFigureOut">
              <a:rPr lang="en-US" smtClean="0"/>
              <a:t>3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6F7F49-2D42-7F4D-957C-E99E31D95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8F7D64-46A3-474C-835D-3378AB513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63335-745E-6448-8ECA-B389D5C33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827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E0A4A0-5A77-B34A-9466-768A0C622F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728DC49-7C16-0649-BC89-17BE818E39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3B7A9D-5EDB-3C48-8D9D-F791C2BAE4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91F0FF-3966-064E-9816-8DE690C287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488E0-DCBF-FB4E-90E8-11620C376D18}" type="datetimeFigureOut">
              <a:rPr lang="en-US" smtClean="0"/>
              <a:t>3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248650-D0BE-2542-A94D-B10D8600C2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B2392-3A3D-6C4C-853C-2BAA1AABA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63335-745E-6448-8ECA-B389D5C33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098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5444CC1-33E7-6F49-A01C-B204F96C7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C0DF8B-6A16-044A-9272-12AD2CECF2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791DA1-84F0-8C49-8EAD-7EAF4961B8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0488E0-DCBF-FB4E-90E8-11620C376D18}" type="datetimeFigureOut">
              <a:rPr lang="en-US" smtClean="0"/>
              <a:t>3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47D80C-1B5A-ED4E-B96B-A965824B45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67D463-6640-2348-A3EF-848820F63F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363335-745E-6448-8ECA-B389D5C33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086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https://upload.wikimedia.org/wikipedia/commons/thumb/d/dc/ETTubeandNGtube.png/554px-ETTubeandNGtube.png?20160528132634" TargetMode="Externa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https://upload.wikimedia.org/wikipedia/commons/thumb/e/ed/Torsades_converted_by_AICD_ECG_strip_Lead_II.JPG/800px-Torsades_converted_by_AICD_ECG_strip_Lead_II.JPG?20080503191912" TargetMode="External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https://upload.wikimedia.org/wikipedia/commons/thumb/d/df/ECG_Sinus_Tachycardia_132_bpm.jpg/800px-ECG_Sinus_Tachycardia_132_bpm.jpg?20201113162345" TargetMode="External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639298-3996-EF4A-9BC9-8E9D0DA10A2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Torsade de Pointes Due to Hypokalemia and Hypomagnesemia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2C4DC7-C2BE-094F-9334-B928C4AFD67E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7773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2107A0-6106-0B49-A9A7-CE911B1BD5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Post-intubation CXR </a:t>
            </a:r>
            <a:endParaRPr lang="en-US" dirty="0"/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BD017365-7406-FB44-8DC2-8A801E09495A}"/>
              </a:ext>
            </a:extLst>
          </p:cNvPr>
          <p:cNvSpPr>
            <a:spLocks noChangeArrowheads="1"/>
          </p:cNvSpPr>
          <p:nvPr/>
        </p:nvSpPr>
        <p:spPr bwMode="auto">
          <a:xfrm flipV="1">
            <a:off x="4369800" y="698499"/>
            <a:ext cx="11073399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10" descr="A close-up of a fetus&#10;&#10;Description automatically generated with low confidence">
            <a:extLst>
              <a:ext uri="{FF2B5EF4-FFF2-40B4-BE49-F238E27FC236}">
                <a16:creationId xmlns:a16="http://schemas.microsoft.com/office/drawing/2014/main" id="{4809D733-5463-4244-BAE5-A250B9C40DA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r:link="rId4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6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3214" y="1263626"/>
            <a:ext cx="5167586" cy="55943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7200785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B4538F-0900-C54C-9A5E-CBA172FD05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ECG strip </a:t>
            </a:r>
            <a:endParaRPr lang="en-US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040B705-D8D0-174F-9E1C-C9B245A0C1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8200" y="3078050"/>
            <a:ext cx="20857388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2049" name="Picture 12" descr="A picture containing text&#10;&#10;Description automatically generated">
            <a:extLst>
              <a:ext uri="{FF2B5EF4-FFF2-40B4-BE49-F238E27FC236}">
                <a16:creationId xmlns:a16="http://schemas.microsoft.com/office/drawing/2014/main" id="{F7B24E5A-D864-B143-8274-F1CA9E7187B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r:link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078" r="15802" b="18829"/>
          <a:stretch>
            <a:fillRect/>
          </a:stretch>
        </p:blipFill>
        <p:spPr bwMode="auto">
          <a:xfrm>
            <a:off x="838200" y="3078050"/>
            <a:ext cx="10673586" cy="16098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5282017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26AD05-8AA4-E741-82DF-C1CEED47BD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Post-ROSC ECG </a:t>
            </a:r>
            <a:endParaRPr lang="en-US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B921DFAE-AF1B-634F-A5D2-81484C9365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3718" y="1909978"/>
            <a:ext cx="20368433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3073" name="Picture 11" descr="A picture containing chart&#10;&#10;Description automatically generated">
            <a:extLst>
              <a:ext uri="{FF2B5EF4-FFF2-40B4-BE49-F238E27FC236}">
                <a16:creationId xmlns:a16="http://schemas.microsoft.com/office/drawing/2014/main" id="{1B695FBA-1A20-DF4C-A544-2EBDDA6749A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r:link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3718" y="1909978"/>
            <a:ext cx="9929611" cy="45828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4389284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67B66E-E4E0-2F42-BA2C-0299ABED47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Electrocardiogram</a:t>
            </a:r>
            <a:r>
              <a:rPr lang="en-US" dirty="0">
                <a:effectLst/>
              </a:rPr>
              <a:t> # 1</a:t>
            </a:r>
            <a:endParaRPr lang="en-US" dirty="0"/>
          </a:p>
        </p:txBody>
      </p:sp>
      <p:pic>
        <p:nvPicPr>
          <p:cNvPr id="3" name="Picture 2" descr="A picture containing chart&#10;&#10;Description automatically generated">
            <a:extLst>
              <a:ext uri="{FF2B5EF4-FFF2-40B4-BE49-F238E27FC236}">
                <a16:creationId xmlns:a16="http://schemas.microsoft.com/office/drawing/2014/main" id="{CC4DECEE-A03D-1D45-A455-2F513C193B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8766" y="1497898"/>
            <a:ext cx="9456682" cy="5108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60789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F21D20-F65E-C547-B437-6308AA16D7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Complete Blood Count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C01267-504B-1749-B7A5-E669C680BF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hite blood count (WBC) 13.3 x 1000/mm</a:t>
            </a:r>
            <a:r>
              <a:rPr lang="en-US" baseline="30000" dirty="0"/>
              <a:t>3 </a:t>
            </a:r>
            <a:r>
              <a:rPr lang="en-US" dirty="0"/>
              <a:t>(H)</a:t>
            </a:r>
          </a:p>
          <a:p>
            <a:r>
              <a:rPr lang="en-US" dirty="0"/>
              <a:t>Hemoglobin (Hgb) 12.7g/dL</a:t>
            </a:r>
          </a:p>
          <a:p>
            <a:r>
              <a:rPr lang="en-US" dirty="0"/>
              <a:t>Hematocrit (HCT) 35.7%</a:t>
            </a:r>
          </a:p>
          <a:p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 348 x 1000/mm</a:t>
            </a:r>
            <a:r>
              <a:rPr lang="en-US" baseline="30000" dirty="0"/>
              <a:t>3 </a:t>
            </a:r>
            <a:r>
              <a:rPr lang="en-US" dirty="0"/>
              <a:t>(H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30202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C1E45C-FAD3-7044-8E0F-2304A82872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Basic Metabolic Panel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3093EB-4A2B-144A-91A2-EF752D3BCB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Sodium 140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r>
              <a:rPr lang="en-US" dirty="0"/>
              <a:t>Potassium 2.9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r>
              <a:rPr lang="en-US" dirty="0"/>
              <a:t>Chloride 102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r>
              <a:rPr lang="en-US" dirty="0"/>
              <a:t>Bicarbonate (HCO3) 24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r>
              <a:rPr lang="en-US" dirty="0"/>
              <a:t>Blood Urea Nitrogen (BUN) 21 mg/dL</a:t>
            </a:r>
          </a:p>
          <a:p>
            <a:r>
              <a:rPr lang="en-US" dirty="0"/>
              <a:t>Creatinine 0.71 mg/dL</a:t>
            </a:r>
          </a:p>
          <a:p>
            <a:r>
              <a:rPr lang="en-US" dirty="0"/>
              <a:t>Glucose 177 mg/dL</a:t>
            </a:r>
          </a:p>
          <a:p>
            <a:r>
              <a:rPr lang="en-US" dirty="0"/>
              <a:t>Calcium 8.7 mg/dL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25527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A3DB19-7BE6-1241-B172-9FAC06437D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Lactate and Magnesiu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BF9672-2C91-C448-A89A-A4A29265B0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Lactate 3.1 mg/dL</a:t>
            </a:r>
          </a:p>
          <a:p>
            <a:r>
              <a:rPr lang="en-US" dirty="0"/>
              <a:t>Magnesium 0.9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58687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A643B-D352-274D-A706-F5A53133E7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Serum toxicologic drug scree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01EEE4-18AB-FC48-8952-023CA4148E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EtOH – negative</a:t>
            </a:r>
          </a:p>
          <a:p>
            <a:r>
              <a:rPr lang="en-US" dirty="0"/>
              <a:t>Salicylate – negative</a:t>
            </a:r>
          </a:p>
          <a:p>
            <a:r>
              <a:rPr lang="en-US" dirty="0"/>
              <a:t>Acetaminophen - negative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17418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71C166-1685-DA4E-8FE7-F7A6989187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Urinalysi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048F51-F453-A84A-9068-997099F7C9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55000" lnSpcReduction="20000"/>
          </a:bodyPr>
          <a:lstStyle/>
          <a:p>
            <a:r>
              <a:rPr lang="en-US" dirty="0">
                <a:sym typeface="Symbol" pitchFamily="2" charset="2"/>
              </a:rPr>
              <a:t></a:t>
            </a:r>
            <a:r>
              <a:rPr lang="en-US" dirty="0"/>
              <a:t>-HCG – negative</a:t>
            </a:r>
          </a:p>
          <a:p>
            <a:r>
              <a:rPr lang="en-US" dirty="0"/>
              <a:t> </a:t>
            </a:r>
          </a:p>
          <a:p>
            <a:r>
              <a:rPr lang="en-US" dirty="0"/>
              <a:t>Color - Yellow</a:t>
            </a:r>
          </a:p>
          <a:p>
            <a:r>
              <a:rPr lang="en-US" dirty="0"/>
              <a:t>Appearance - Clear</a:t>
            </a:r>
          </a:p>
          <a:p>
            <a:r>
              <a:rPr lang="en-US" dirty="0"/>
              <a:t>Specific gravity - 1.10</a:t>
            </a:r>
          </a:p>
          <a:p>
            <a:r>
              <a:rPr lang="en-US" dirty="0"/>
              <a:t>pH - 7.0</a:t>
            </a:r>
          </a:p>
          <a:p>
            <a:r>
              <a:rPr lang="en-US" dirty="0"/>
              <a:t>Glucose - negative</a:t>
            </a:r>
          </a:p>
          <a:p>
            <a:r>
              <a:rPr lang="en-US" dirty="0"/>
              <a:t>Bilirubin - negative</a:t>
            </a:r>
          </a:p>
          <a:p>
            <a:r>
              <a:rPr lang="en-US" dirty="0"/>
              <a:t>Ketones - 2+</a:t>
            </a:r>
          </a:p>
          <a:p>
            <a:r>
              <a:rPr lang="en-US" dirty="0"/>
              <a:t>Protein - 2+</a:t>
            </a:r>
          </a:p>
          <a:p>
            <a:r>
              <a:rPr lang="en-US" dirty="0"/>
              <a:t>Nitrite - negative</a:t>
            </a:r>
          </a:p>
          <a:p>
            <a:r>
              <a:rPr lang="en-US" dirty="0"/>
              <a:t>Leukocyte esterase - negative</a:t>
            </a:r>
          </a:p>
          <a:p>
            <a:r>
              <a:rPr lang="en-US" dirty="0"/>
              <a:t>WBC - 0-5/</a:t>
            </a:r>
            <a:r>
              <a:rPr lang="en-US" dirty="0" err="1"/>
              <a:t>hpf</a:t>
            </a:r>
            <a:endParaRPr lang="en-US" dirty="0"/>
          </a:p>
          <a:p>
            <a:r>
              <a:rPr lang="en-US" dirty="0"/>
              <a:t>RBC - 0-5/</a:t>
            </a:r>
            <a:r>
              <a:rPr lang="en-US" dirty="0" err="1"/>
              <a:t>hpf</a:t>
            </a:r>
            <a:endParaRPr lang="en-US" dirty="0"/>
          </a:p>
          <a:p>
            <a:r>
              <a:rPr lang="en-US" dirty="0"/>
              <a:t>Squamous epithelial cells - 0-5/</a:t>
            </a:r>
            <a:r>
              <a:rPr lang="en-US" dirty="0" err="1"/>
              <a:t>hpf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91235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D58459-7862-784D-8FF3-EDDF34130C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Urine drug screen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A856AC-17E2-BF4B-9C64-1CC471F720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/>
              <a:t>Amphetamine - positive</a:t>
            </a:r>
          </a:p>
          <a:p>
            <a:r>
              <a:rPr lang="en-US" dirty="0"/>
              <a:t>Barbiturate - negative</a:t>
            </a:r>
          </a:p>
          <a:p>
            <a:r>
              <a:rPr lang="en-US" dirty="0"/>
              <a:t>Benzodiazepine - negative</a:t>
            </a:r>
          </a:p>
          <a:p>
            <a:r>
              <a:rPr lang="en-US" dirty="0"/>
              <a:t>Cocaine - negative</a:t>
            </a:r>
          </a:p>
          <a:p>
            <a:r>
              <a:rPr lang="en-US" dirty="0"/>
              <a:t>Marijuana - negative</a:t>
            </a:r>
          </a:p>
          <a:p>
            <a:r>
              <a:rPr lang="en-US" dirty="0"/>
              <a:t>Methadone - negative</a:t>
            </a:r>
          </a:p>
          <a:p>
            <a:r>
              <a:rPr lang="en-US" dirty="0"/>
              <a:t>Methamphetamine - positive</a:t>
            </a:r>
          </a:p>
          <a:p>
            <a:r>
              <a:rPr lang="en-US" dirty="0"/>
              <a:t>Opiate - negative</a:t>
            </a:r>
          </a:p>
          <a:p>
            <a:r>
              <a:rPr lang="en-US" dirty="0" err="1"/>
              <a:t>Phenocyclidine</a:t>
            </a:r>
            <a:r>
              <a:rPr lang="en-US" dirty="0"/>
              <a:t> - negative</a:t>
            </a:r>
          </a:p>
          <a:p>
            <a:r>
              <a:rPr lang="en-US" dirty="0"/>
              <a:t>Tricyclic antidepressants - negative</a:t>
            </a:r>
          </a:p>
        </p:txBody>
      </p:sp>
    </p:spTree>
    <p:extLst>
      <p:ext uri="{BB962C8B-B14F-4D97-AF65-F5344CB8AC3E}">
        <p14:creationId xmlns:p14="http://schemas.microsoft.com/office/powerpoint/2010/main" val="135923807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C8A042-C5BA-9C4E-857F-300A6D827D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CT head </a:t>
            </a:r>
            <a:endParaRPr lang="en-US" dirty="0"/>
          </a:p>
        </p:txBody>
      </p:sp>
      <p:pic>
        <p:nvPicPr>
          <p:cNvPr id="3" name="Picture 2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38F0ECB1-AA8F-D94E-8BB2-8AE62CB045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08099" y="1417976"/>
            <a:ext cx="5630534" cy="54400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0870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30</Words>
  <Application>Microsoft Macintosh PowerPoint</Application>
  <PresentationFormat>Widescreen</PresentationFormat>
  <Paragraphs>54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Torsade de Pointes Due to Hypokalemia and Hypomagnesemia </vt:lpstr>
      <vt:lpstr>Electrocardiogram # 1</vt:lpstr>
      <vt:lpstr>Complete Blood Count</vt:lpstr>
      <vt:lpstr>Basic Metabolic Panel</vt:lpstr>
      <vt:lpstr>Lactate and Magnesium</vt:lpstr>
      <vt:lpstr>Serum toxicologic drug screen</vt:lpstr>
      <vt:lpstr>Urinalysis</vt:lpstr>
      <vt:lpstr>Urine drug screen</vt:lpstr>
      <vt:lpstr>CT head </vt:lpstr>
      <vt:lpstr>Post-intubation CXR </vt:lpstr>
      <vt:lpstr>ECG strip </vt:lpstr>
      <vt:lpstr>Post-ROSC ECG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orsade de Pointes Due to Hypokalemia and Hypomagnesemia </dc:title>
  <dc:creator>Amrita Vempati</dc:creator>
  <cp:lastModifiedBy>Amrita Vempati</cp:lastModifiedBy>
  <cp:revision>1</cp:revision>
  <dcterms:created xsi:type="dcterms:W3CDTF">2022-03-18T18:29:49Z</dcterms:created>
  <dcterms:modified xsi:type="dcterms:W3CDTF">2022-03-18T18:38:11Z</dcterms:modified>
</cp:coreProperties>
</file>